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8"/>
    <p:restoredTop sz="96327"/>
  </p:normalViewPr>
  <p:slideViewPr>
    <p:cSldViewPr snapToGrid="0" snapToObjects="1">
      <p:cViewPr varScale="1">
        <p:scale>
          <a:sx n="116" d="100"/>
          <a:sy n="116" d="100"/>
        </p:scale>
        <p:origin x="216" y="5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BEB19-3E7D-4A4A-96B8-7DFE6B8273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EF9A4F-702B-DD4A-9FAE-581CF2FB4F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47888A-8557-EB4B-B0F3-065536BEB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B5C6F8-5508-7940-BCE4-CA9788624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29FAE-182D-7A48-BEA2-08484A186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597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ACECC4-152B-2C40-A434-E51EF9528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38944B-29FD-7143-8E2B-4AB6E62395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C70DF-BBE0-DE44-AB34-38C9FB8FB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D2036A-FEAC-8D43-AF23-8C91AA352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5CEAD5-1A5C-0A4A-9D4F-DD683D631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162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6E2830-6908-1446-BE77-B35F74F964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4D7D9F-E325-AF44-B00D-919B72DCC8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6C0C08-337E-0B4A-B8E7-9452C2C4D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FEC07A-C5D3-0148-8FCD-2FD5D8691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BEB281-E2EC-754F-B6F1-270CE10F4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716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2129C0-E218-8748-863E-BF948A33AC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A5DF72-8B0D-7C44-9ECD-D7522AC695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8A88BF-1A05-F34C-B213-02DF77481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1EB7F3-4C23-5F41-B339-7409F20BD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3C0E1-83ED-B84F-90A9-9BA054F2A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819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EC24E2-05B2-3846-9F73-1D116A911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B03C5A-9E6A-4140-A30A-4EF3BD2E7B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83EF0A-49C0-4949-B97A-681C868AF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205CD5-5479-D043-A539-8CBCD4241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C5E289-B1AF-C043-B698-65ADF9566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117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63D3C-14B9-EB4A-A489-E7FB673999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D0D236-DBA1-214E-A6C1-8CABB4E7F8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FF14EF-5DC2-D745-98C8-BE3BF081B3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9BD995-2DF5-1D4C-B4AA-B85C2647D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D78DCA-C44F-FC42-9C3B-16C80D59C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04A5F5-BA54-4344-9E2C-3776DB66C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420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00D6AD-2FC1-8E41-B846-99D14EA2B5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D6D8C5-1D29-A64D-9E55-89CD6AF72A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F06FC6-656A-754C-AFA0-DD71B50A6D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29C234-B6AB-6D44-A0F4-F51F14C6D5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A62F4B-998E-6C47-A64B-2E2315FB41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A41586-2757-3745-A2CB-F0E8EE987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1A7A70B-0B5E-0F4F-8B2A-4455B7F1F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B0E047-1E99-E242-AF10-D0E4FB892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254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CB87CB-3E04-084F-9284-5A13AE4717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54E4CD-540B-7541-835D-2511A73CE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F02575-39C7-6046-8F78-1B3AC4D50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7D3FE9-9355-1F4D-BFDE-E54C9D28E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497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CD0B8E0-4819-BE45-A91E-8DF52C190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7163D4-1A36-C74C-93A9-02DE728AF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84DECD-E1F9-BA45-93DF-499643783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423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4EA50-2E40-624F-AD6D-0F2CFD599B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F1A150-9DB4-2E4E-8BFD-8222F1C458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B9BC84-E0DD-F14D-84B4-3FD7F157C6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7139C2-E6C2-6741-B26C-37A80DB2B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571EBB-F681-FA47-8261-22A287D11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FBF556-4913-5F4F-BA18-93E946475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332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E73953-8187-3E4D-BA7E-1B504184B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1F8786-9473-1341-8671-64539057CC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687661-0C1B-A84C-B658-975800071B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174991-EFE5-9242-8CB5-D13D74512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1870CE-C8A0-AB4D-B806-A0E132ADD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74B76C-F6E2-F342-969B-119807740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954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545AF8-23E5-284D-A3C7-C85F08BD82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2E97D0-FE26-A948-8FFE-4512AF3210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53A28-99D1-CF4A-8591-DC8859D67E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DB997-FE67-384F-A1C5-608DC295146C}" type="datetimeFigureOut">
              <a:rPr lang="en-US" smtClean="0"/>
              <a:t>9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F08AAF-95D5-4D44-934C-DC346BE36B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B0C580-2EFC-2849-AE43-4A959A495B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DD7611-7EC4-E44B-BB39-D8A79C549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650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Table&#10;&#10;Description automatically generated">
            <a:extLst>
              <a:ext uri="{FF2B5EF4-FFF2-40B4-BE49-F238E27FC236}">
                <a16:creationId xmlns:a16="http://schemas.microsoft.com/office/drawing/2014/main" id="{34D5C5CF-7414-E142-A4AC-3E5455F7A3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6150" y="2241550"/>
            <a:ext cx="10299700" cy="23749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09337DD2-871A-754B-8956-74392CFC02B6}"/>
              </a:ext>
            </a:extLst>
          </p:cNvPr>
          <p:cNvSpPr/>
          <p:nvPr/>
        </p:nvSpPr>
        <p:spPr>
          <a:xfrm>
            <a:off x="946150" y="4779221"/>
            <a:ext cx="101790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Table 2. </a:t>
            </a:r>
            <a:r>
              <a:rPr lang="en-US" dirty="0" err="1"/>
              <a:t>Fluorospot</a:t>
            </a:r>
            <a:r>
              <a:rPr lang="en-US" dirty="0"/>
              <a:t> data p values (Wilcoxon test) differences between week 16 and week 0 in IFN-</a:t>
            </a:r>
            <a:r>
              <a:rPr lang="en-US" dirty="0" err="1"/>
              <a:t>γ</a:t>
            </a:r>
            <a:r>
              <a:rPr lang="en-US" dirty="0"/>
              <a:t> and IL-17A secreting T cells stimulated with Proinsulin, GAD65, </a:t>
            </a:r>
            <a:r>
              <a:rPr lang="en-US" dirty="0" err="1"/>
              <a:t>Infarix</a:t>
            </a:r>
            <a:r>
              <a:rPr lang="en-US" dirty="0"/>
              <a:t>/Candida. Table shows all samples combined and 90mg and 45mg cohorts separated. Shaded boxes indicate significance.</a:t>
            </a:r>
          </a:p>
        </p:txBody>
      </p:sp>
    </p:spTree>
    <p:extLst>
      <p:ext uri="{BB962C8B-B14F-4D97-AF65-F5344CB8AC3E}">
        <p14:creationId xmlns:p14="http://schemas.microsoft.com/office/powerpoint/2010/main" val="1066493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53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ish Marwaha</dc:creator>
  <cp:lastModifiedBy>Chow, Samuel</cp:lastModifiedBy>
  <cp:revision>7</cp:revision>
  <dcterms:created xsi:type="dcterms:W3CDTF">2020-10-14T23:50:40Z</dcterms:created>
  <dcterms:modified xsi:type="dcterms:W3CDTF">2021-09-14T18:25:53Z</dcterms:modified>
</cp:coreProperties>
</file>